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106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3226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7266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829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447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91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423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1378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4547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323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5401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346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DBE57F-9B0F-4449-8A90-DF6DFEC00D73}" type="datetimeFigureOut">
              <a:rPr lang="zh-CN" altLang="en-US" smtClean="0"/>
              <a:t>2019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3756CC-D097-4E13-B6E1-B2E3C55E62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91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E150FF-F286-4087-94AB-4BDB04B77AE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/>
              <a:t>Additional file 6</a:t>
            </a:r>
            <a:endParaRPr lang="zh-CN" altLang="en-US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30762AC-BA9F-469F-95E3-7CFFB8807E6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CN" dirty="0"/>
              <a:t>A cartoon about the benefits of low salt and low fa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695426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2A8D37-A57F-4234-A1AC-413DDFAA93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C682541A-2D06-4D68-A83C-0941F6436CF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268" y="81951"/>
            <a:ext cx="8925464" cy="6694098"/>
          </a:xfrm>
        </p:spPr>
      </p:pic>
    </p:spTree>
    <p:extLst>
      <p:ext uri="{BB962C8B-B14F-4D97-AF65-F5344CB8AC3E}">
        <p14:creationId xmlns:p14="http://schemas.microsoft.com/office/powerpoint/2010/main" val="625710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ACBD44-AA8B-4BA6-960A-DF19924EB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46FC27B5-74F1-44B8-B56F-EF1FBF5B16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275" y="116456"/>
            <a:ext cx="8833449" cy="6625087"/>
          </a:xfrm>
        </p:spPr>
      </p:pic>
    </p:spTree>
    <p:extLst>
      <p:ext uri="{BB962C8B-B14F-4D97-AF65-F5344CB8AC3E}">
        <p14:creationId xmlns:p14="http://schemas.microsoft.com/office/powerpoint/2010/main" val="23866932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8F516C-E1AC-4DB6-9A7C-1D4B1CBF54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8B35F77C-CCFB-487F-80D5-E23ACCFD352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523" y="202893"/>
            <a:ext cx="8726827" cy="6545120"/>
          </a:xfrm>
        </p:spPr>
      </p:pic>
    </p:spTree>
    <p:extLst>
      <p:ext uri="{BB962C8B-B14F-4D97-AF65-F5344CB8AC3E}">
        <p14:creationId xmlns:p14="http://schemas.microsoft.com/office/powerpoint/2010/main" val="1549238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B244D9-44F3-4641-BA3C-686777D442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84A751-B991-4FD9-AA69-504C0DBD29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9D1C5A9-55CA-4346-A40C-9504028C4A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72737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68CCA9-3C4F-461F-8BCE-5838C9074C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DA189C-4557-4E94-BB07-68BF633C4B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79B9F28-791E-45F9-9457-60D6AD8AB9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5850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3E9D13-FB28-47C5-91A7-3D116EB92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74EAF3-F4C4-4859-B5C3-D387B05F28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14A8467-322C-4243-8F86-49792E2E10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571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4</Words>
  <Application>Microsoft Office PowerPoint</Application>
  <PresentationFormat>全屏显示(4:3)</PresentationFormat>
  <Paragraphs>2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主题​​</vt:lpstr>
      <vt:lpstr>Additional file 6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pendix 6</dc:title>
  <dc:creator>yuling chen</dc:creator>
  <cp:lastModifiedBy>yuling chen</cp:lastModifiedBy>
  <cp:revision>6</cp:revision>
  <dcterms:created xsi:type="dcterms:W3CDTF">2019-02-13T07:01:26Z</dcterms:created>
  <dcterms:modified xsi:type="dcterms:W3CDTF">2019-05-07T09:44:44Z</dcterms:modified>
</cp:coreProperties>
</file>